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095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140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659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584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88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991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467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328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770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281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558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0BA4F-ACF9-432A-9552-EA298E9A8549}" type="datetimeFigureOut">
              <a:rPr lang="en-US" smtClean="0"/>
              <a:t>3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2B7F1-55A7-4DD9-87E5-B8AA032D2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354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B80CB396-DBF1-475F-AB75-B82E1EEFE8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700" y="1028700"/>
            <a:ext cx="7848600" cy="480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47706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14A154A0-7CAB-4891-A512-8B65B8EBAC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2030" y="567690"/>
            <a:ext cx="7139940" cy="5722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85452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9C3930F6-DFF5-4094-B50C-AC2588FC40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50443"/>
            <a:ext cx="8178799" cy="5357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95010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5CB2910A-9D61-4983-A952-014D16FB01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8220" y="613410"/>
            <a:ext cx="7147560" cy="56311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599446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22DCB100-DF80-47D6-B14F-72150A7BEE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060" y="1017270"/>
            <a:ext cx="7421880" cy="4823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832133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8425C5D7-0335-4750-B1B7-6A827C6815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830" y="594360"/>
            <a:ext cx="7292340" cy="5669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61186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1C251B52-8749-483A-BACA-B1D248A8E3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340" y="1074420"/>
            <a:ext cx="7513320" cy="4709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32698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4C28146E-11DD-4107-AB38-9443D0CD96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2030" y="605790"/>
            <a:ext cx="7139940" cy="5646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35914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C0ACFF9A-190A-45C0-B6C6-967AD7E82F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320" y="769620"/>
            <a:ext cx="7833360" cy="5318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07139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C10964C-209F-473A-A0F6-AC1370929C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910" y="1123950"/>
            <a:ext cx="7536180" cy="461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78237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18B3A8DC-5C99-4C29-9FF7-31C034D7FD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4410" y="560070"/>
            <a:ext cx="7155180" cy="57378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47244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428EDDAC-D6B0-4CBC-BC74-E13E1C28A3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020" y="1131570"/>
            <a:ext cx="7299960" cy="45948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73268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social media post&#10;&#10;Description automatically generated">
            <a:extLst>
              <a:ext uri="{FF2B5EF4-FFF2-40B4-BE49-F238E27FC236}">
                <a16:creationId xmlns:a16="http://schemas.microsoft.com/office/drawing/2014/main" id="{B0DD9DDA-856A-4E82-AED9-D898970817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890" y="472440"/>
            <a:ext cx="7094220" cy="5913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11265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0E477DD3-B99A-482F-8693-B8C21B8AA7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010" y="1093470"/>
            <a:ext cx="7459980" cy="46710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71122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C926FCEC-6856-4E14-9BD9-720C12821F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7270" y="529590"/>
            <a:ext cx="7109460" cy="5798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31885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4A7EFFCE-A47B-40C5-B28A-1F37546ACC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540" y="1040130"/>
            <a:ext cx="7360920" cy="47777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4697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0</Words>
  <Application>Microsoft Office PowerPoint</Application>
  <PresentationFormat>On-screen Show (4:3)</PresentationFormat>
  <Paragraphs>0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son Lai</dc:creator>
  <cp:lastModifiedBy>Jason Lai</cp:lastModifiedBy>
  <cp:revision>2</cp:revision>
  <dcterms:created xsi:type="dcterms:W3CDTF">2020-03-10T20:10:40Z</dcterms:created>
  <dcterms:modified xsi:type="dcterms:W3CDTF">2020-03-10T21:17:12Z</dcterms:modified>
</cp:coreProperties>
</file>